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2193588" cy="6858000"/>
  <p:notesSz cx="7559675" cy="10691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"/>
          <p:cNvSpPr/>
          <p:nvPr/>
        </p:nvSpPr>
        <p:spPr>
          <a:xfrm>
            <a:off x="0" y="0"/>
            <a:ext cx="7560000" cy="10692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1"/>
          <p:cNvSpPr>
            <a:spLocks noGrp="1"/>
          </p:cNvSpPr>
          <p:nvPr>
            <p:ph type="sldImg"/>
          </p:nvPr>
        </p:nvSpPr>
        <p:spPr>
          <a:xfrm>
            <a:off x="1106280" y="812880"/>
            <a:ext cx="5343480" cy="400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2"/>
          <p:cNvSpPr>
            <a:spLocks noGrp="1"/>
          </p:cNvSpPr>
          <p:nvPr>
            <p:ph type="body"/>
          </p:nvPr>
        </p:nvSpPr>
        <p:spPr>
          <a:xfrm>
            <a:off x="755280" y="5078160"/>
            <a:ext cx="6046920" cy="4809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" name="PlaceHolder 3"/>
          <p:cNvSpPr>
            <a:spLocks noGrp="1"/>
          </p:cNvSpPr>
          <p:nvPr>
            <p:ph type="hdr"/>
          </p:nvPr>
        </p:nvSpPr>
        <p:spPr>
          <a:xfrm>
            <a:off x="0" y="0"/>
            <a:ext cx="3279600" cy="53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4"/>
          <p:cNvSpPr>
            <a:spLocks noGrp="1"/>
          </p:cNvSpPr>
          <p:nvPr>
            <p:ph type="dt" idx="1"/>
          </p:nvPr>
        </p:nvSpPr>
        <p:spPr>
          <a:xfrm>
            <a:off x="4277880" y="0"/>
            <a:ext cx="3279960" cy="53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5"/>
          <p:cNvSpPr>
            <a:spLocks noGrp="1"/>
          </p:cNvSpPr>
          <p:nvPr>
            <p:ph type="ftr" idx="2"/>
          </p:nvPr>
        </p:nvSpPr>
        <p:spPr>
          <a:xfrm>
            <a:off x="0" y="10156680"/>
            <a:ext cx="3279600" cy="53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6"/>
          <p:cNvSpPr>
            <a:spLocks noGrp="1"/>
          </p:cNvSpPr>
          <p:nvPr>
            <p:ph type="sldNum" idx="3"/>
          </p:nvPr>
        </p:nvSpPr>
        <p:spPr>
          <a:xfrm>
            <a:off x="4277880" y="10156680"/>
            <a:ext cx="3279960" cy="53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95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es-E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95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350FACDE-DDA0-4DD2-9FEF-39903697EA61}" type="slidenum">
              <a:rPr b="0" lang="es-E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Rectangle 6"/>
          <p:cNvSpPr/>
          <p:nvPr/>
        </p:nvSpPr>
        <p:spPr>
          <a:xfrm>
            <a:off x="4278240" y="10156680"/>
            <a:ext cx="3279960" cy="53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95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4EA2AC06-2180-43C8-8E56-F31C28762B23}" type="slidenum">
              <a:rPr b="0" lang="es-E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1"/>
          <p:cNvSpPr>
            <a:spLocks noGrp="1"/>
          </p:cNvSpPr>
          <p:nvPr>
            <p:ph type="sldImg"/>
          </p:nvPr>
        </p:nvSpPr>
        <p:spPr>
          <a:xfrm>
            <a:off x="217440" y="812880"/>
            <a:ext cx="7124760" cy="4008240"/>
          </a:xfrm>
          <a:prstGeom prst="rect">
            <a:avLst/>
          </a:prstGeom>
          <a:ln w="0">
            <a:noFill/>
          </a:ln>
        </p:spPr>
      </p:sp>
      <p:sp>
        <p:nvSpPr>
          <p:cNvPr id="49" name="PlaceHolder 2"/>
          <p:cNvSpPr>
            <a:spLocks noGrp="1"/>
          </p:cNvSpPr>
          <p:nvPr>
            <p:ph type="body"/>
          </p:nvPr>
        </p:nvSpPr>
        <p:spPr>
          <a:xfrm>
            <a:off x="755280" y="5078520"/>
            <a:ext cx="6048360" cy="4811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1097136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609480" y="3681360"/>
            <a:ext cx="1097136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/>
          </p:nvPr>
        </p:nvSpPr>
        <p:spPr>
          <a:xfrm>
            <a:off x="609480" y="368136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/>
          </p:nvPr>
        </p:nvSpPr>
        <p:spPr>
          <a:xfrm>
            <a:off x="6231600" y="368136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353268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/>
          </p:nvPr>
        </p:nvSpPr>
        <p:spPr>
          <a:xfrm>
            <a:off x="4319280" y="1604880"/>
            <a:ext cx="353268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/>
          </p:nvPr>
        </p:nvSpPr>
        <p:spPr>
          <a:xfrm>
            <a:off x="8028720" y="1604880"/>
            <a:ext cx="353268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/>
          </p:nvPr>
        </p:nvSpPr>
        <p:spPr>
          <a:xfrm>
            <a:off x="609480" y="3681360"/>
            <a:ext cx="353268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/>
          </p:nvPr>
        </p:nvSpPr>
        <p:spPr>
          <a:xfrm>
            <a:off x="4319280" y="3681360"/>
            <a:ext cx="353268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/>
          </p:nvPr>
        </p:nvSpPr>
        <p:spPr>
          <a:xfrm>
            <a:off x="8028720" y="3681360"/>
            <a:ext cx="353268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609480" y="1604880"/>
            <a:ext cx="1097136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1097136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609480" y="272520"/>
            <a:ext cx="1097136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3000"/>
              </a:lnSpc>
              <a:spcBef>
                <a:spcPts val="1426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/>
          </p:nvPr>
        </p:nvSpPr>
        <p:spPr>
          <a:xfrm>
            <a:off x="609480" y="368136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6231600" y="368136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609480" y="160488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6231600" y="1604880"/>
            <a:ext cx="535392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609480" y="3681360"/>
            <a:ext cx="10971360" cy="1896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/>
          </a:bodyPr>
          <a:p>
            <a:pPr marL="343080" indent="0">
              <a:lnSpc>
                <a:spcPct val="93000"/>
              </a:lnSpc>
              <a:spcBef>
                <a:spcPts val="1426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09480" y="272520"/>
            <a:ext cx="10971360" cy="1143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09480" y="1604880"/>
            <a:ext cx="10971360" cy="3975120"/>
          </a:xfrm>
          <a:prstGeom prst="rect">
            <a:avLst/>
          </a:prstGeom>
          <a:noFill/>
          <a:ln w="0">
            <a:noFill/>
          </a:ln>
        </p:spPr>
        <p:txBody>
          <a:bodyPr lIns="0" rIns="0" tIns="28440" bIns="0" anchor="t">
            <a:normAutofit fontScale="92000"/>
          </a:bodyPr>
          <a:p>
            <a:pPr marL="315360" indent="0">
              <a:lnSpc>
                <a:spcPct val="93000"/>
              </a:lnSpc>
              <a:spcBef>
                <a:spcPts val="1426"/>
              </a:spcBef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15360" indent="-315360">
              <a:lnSpc>
                <a:spcPct val="93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15360" indent="-315360">
              <a:lnSpc>
                <a:spcPct val="93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15360" indent="-315360">
              <a:lnSpc>
                <a:spcPct val="93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15360" indent="-315360">
              <a:lnSpc>
                <a:spcPct val="93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15360" indent="-315360">
              <a:lnSpc>
                <a:spcPct val="93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15360" indent="-315360">
              <a:lnSpc>
                <a:spcPct val="93000"/>
              </a:lnSpc>
              <a:spcBef>
                <a:spcPts val="1426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5" name=""/>
          <p:cNvGraphicFramePr/>
          <p:nvPr/>
        </p:nvGraphicFramePr>
        <p:xfrm>
          <a:off x="1847880" y="620640"/>
          <a:ext cx="7311960" cy="3662280"/>
        </p:xfrm>
        <a:graphic>
          <a:graphicData uri="http://schemas.openxmlformats.org/drawingml/2006/table">
            <a:tbl>
              <a:tblPr/>
              <a:tblGrid>
                <a:gridCol w="739800"/>
                <a:gridCol w="268200"/>
                <a:gridCol w="735120"/>
                <a:gridCol w="1733400"/>
                <a:gridCol w="1811520"/>
                <a:gridCol w="966600"/>
                <a:gridCol w="1057320"/>
              </a:tblGrid>
              <a:tr h="604800">
                <a:tc>
                  <a:txBody>
                    <a:bodyPr lIns="7920" rIns="7920" tIns="46800" bIns="468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arget I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H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APINFO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UCSC REF.GENE NAM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ctr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UCSC REF.GENE GROU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ELATION TO UCSC CPG ISLAN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elta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1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on-Responders vs Responder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33440"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g1973763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908791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OC641518;LEF1;LEF1;LEF1;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EF1;LEF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SS1500;1stExon;Body;5'UTR;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Body;Body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slan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2080"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g1401369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718417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OXA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SS150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slan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1720"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g1699764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718415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OXA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SS150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slan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3520"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g0642641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71040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VC2;EVC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'UTR;TSS20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slan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2080"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g1426394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655577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DKL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SS20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slan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2080"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g1034408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655577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DKL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SS20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slan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3520"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g1833667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7073526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LX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SS150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Islan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261720"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g0717658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759638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ZFHX4;LOC10019237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'UTR;TSS150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_Shore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0.2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</a:tr>
              <a:tr h="262080"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g1004303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918540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FERD3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SS150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_Shor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0.2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</a:tr>
              <a:tr h="263520"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g1020848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5060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HL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'UT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_Shor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0.2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</a:tr>
              <a:tr h="261720"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g0208550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73919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IP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SS150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_Shore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46800" bIns="46800" anchor="t">
                      <a:noAutofit/>
                    </a:bodyPr>
                    <a:p>
                      <a:pPr algn="ctr">
                        <a:lnSpc>
                          <a:spcPct val="102000"/>
                        </a:lnSpc>
                        <a:tabLst>
                          <a:tab algn="l" pos="0"/>
                          <a:tab algn="l" pos="449280"/>
                          <a:tab algn="l" pos="898560"/>
                          <a:tab algn="l" pos="1347840"/>
                          <a:tab algn="l" pos="1797120"/>
                          <a:tab algn="l" pos="2246400"/>
                          <a:tab algn="l" pos="2695680"/>
                          <a:tab algn="l" pos="3144960"/>
                          <a:tab algn="l" pos="3594240"/>
                          <a:tab algn="l" pos="4043520"/>
                          <a:tab algn="l" pos="4492800"/>
                          <a:tab algn="l" pos="4941720"/>
                          <a:tab algn="l" pos="5391000"/>
                          <a:tab algn="l" pos="5840280"/>
                          <a:tab algn="l" pos="6289560"/>
                          <a:tab algn="l" pos="6738840"/>
                          <a:tab algn="l" pos="7188120"/>
                          <a:tab algn="l" pos="7637400"/>
                          <a:tab algn="l" pos="8086680"/>
                          <a:tab algn="l" pos="8535960"/>
                          <a:tab algn="l" pos="8985240"/>
                          <a:tab algn="l" pos="9434520"/>
                          <a:tab algn="l" pos="9883800"/>
                          <a:tab algn="l" pos="10333080"/>
                          <a:tab algn="l" pos="10782360"/>
                        </a:tabLst>
                      </a:pPr>
                      <a:r>
                        <a:rPr b="0" lang="es-ES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0.2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920" marR="79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</a:tr>
            </a:tbl>
          </a:graphicData>
        </a:graphic>
      </p:graphicFrame>
      <p:sp>
        <p:nvSpPr>
          <p:cNvPr id="46" name="Rectangle 273"/>
          <p:cNvSpPr/>
          <p:nvPr/>
        </p:nvSpPr>
        <p:spPr>
          <a:xfrm>
            <a:off x="1757520" y="4508640"/>
            <a:ext cx="7402320" cy="792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 algn="just">
              <a:lnSpc>
                <a:spcPct val="107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s-ES" sz="1100" spc="-1" strike="noStrike">
                <a:solidFill>
                  <a:srgbClr val="000000"/>
                </a:solidFill>
                <a:latin typeface="Calibri"/>
              </a:rPr>
              <a:t>Table S3. </a:t>
            </a:r>
            <a:r>
              <a:rPr b="0" lang="es-ES" sz="1100" spc="-1" strike="noStrike">
                <a:solidFill>
                  <a:srgbClr val="000000"/>
                </a:solidFill>
                <a:latin typeface="Calibri"/>
              </a:rPr>
              <a:t>Eleven </a:t>
            </a:r>
            <a:r>
              <a:rPr b="0" lang="es-ES" sz="1100" spc="-1" strike="noStrike">
                <a:solidFill>
                  <a:srgbClr val="000000"/>
                </a:solidFill>
                <a:latin typeface="Calibri"/>
              </a:rPr>
              <a:t>differentially methylated CpGs, 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corresponding to 11 genes, showed significant methylation differences between non-responder and responder patients</a:t>
            </a:r>
            <a:r>
              <a:rPr b="0" lang="es-ES" sz="1100" spc="-1" strike="noStrike">
                <a:solidFill>
                  <a:srgbClr val="000000"/>
                </a:solidFill>
                <a:latin typeface="Calibri"/>
              </a:rPr>
              <a:t>: 6 genes (LOC641518;LEF1; HOXA5; EVC2; CDKL2; TLX3) presented a methylation increase in non-responders group vs responders, and 5 genes (ZFHX4;LOC100192378; FERD3L; CHL1; TRIP10) decreased methylation level in non-responder patients compared to those who responded to NAC treatment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1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12-11T16:19:16Z</dcterms:created>
  <dc:creator>Angel Diaz Lagares</dc:creator>
  <dc:description/>
  <dc:language>en-US</dc:language>
  <cp:lastModifiedBy>JABELLA</cp:lastModifiedBy>
  <cp:lastPrinted>2018-04-16T13:28:07Z</cp:lastPrinted>
  <dcterms:modified xsi:type="dcterms:W3CDTF">2019-02-01T22:50:17Z</dcterms:modified>
  <cp:revision>177</cp:revision>
  <dc:subject/>
  <dc:title>Presentación de PowerPoint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HiddenSlides">
    <vt:r8>0</vt:r8>
  </property>
  <property fmtid="{D5CDD505-2E9C-101B-9397-08002B2CF9AE}" pid="3" name="HyperlinksChanged">
    <vt:bool>0</vt:bool>
  </property>
  <property fmtid="{D5CDD505-2E9C-101B-9397-08002B2CF9AE}" pid="4" name="LinksUpToDate">
    <vt:bool>0</vt:bool>
  </property>
  <property fmtid="{D5CDD505-2E9C-101B-9397-08002B2CF9AE}" pid="5" name="MMClips">
    <vt:r8>0</vt:r8>
  </property>
  <property fmtid="{D5CDD505-2E9C-101B-9397-08002B2CF9AE}" pid="6" name="Notes">
    <vt:r8>0</vt:r8>
  </property>
  <property fmtid="{D5CDD505-2E9C-101B-9397-08002B2CF9AE}" pid="7" name="PresentationFormat">
    <vt:lpwstr>Panorámica</vt:lpwstr>
  </property>
  <property fmtid="{D5CDD505-2E9C-101B-9397-08002B2CF9AE}" pid="8" name="ScaleCrop">
    <vt:bool>0</vt:bool>
  </property>
  <property fmtid="{D5CDD505-2E9C-101B-9397-08002B2CF9AE}" pid="9" name="ShareDoc">
    <vt:bool>0</vt:bool>
  </property>
  <property fmtid="{D5CDD505-2E9C-101B-9397-08002B2CF9AE}" pid="10" name="Slides">
    <vt:r8>18</vt:r8>
  </property>
</Properties>
</file>